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588125" cy="1800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92" y="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3516" y="294620"/>
            <a:ext cx="4941094" cy="626745"/>
          </a:xfrm>
        </p:spPr>
        <p:txBody>
          <a:bodyPr anchor="b"/>
          <a:lstStyle>
            <a:lvl1pPr algn="ctr">
              <a:defRPr sz="15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3516" y="945535"/>
            <a:ext cx="4941094" cy="434638"/>
          </a:xfrm>
        </p:spPr>
        <p:txBody>
          <a:bodyPr/>
          <a:lstStyle>
            <a:lvl1pPr marL="0" indent="0" algn="ctr">
              <a:buNone/>
              <a:defRPr sz="630"/>
            </a:lvl1pPr>
            <a:lvl2pPr marL="120015" indent="0" algn="ctr">
              <a:buNone/>
              <a:defRPr sz="525"/>
            </a:lvl2pPr>
            <a:lvl3pPr marL="240030" indent="0" algn="ctr">
              <a:buNone/>
              <a:defRPr sz="472"/>
            </a:lvl3pPr>
            <a:lvl4pPr marL="360045" indent="0" algn="ctr">
              <a:buNone/>
              <a:defRPr sz="420"/>
            </a:lvl4pPr>
            <a:lvl5pPr marL="480060" indent="0" algn="ctr">
              <a:buNone/>
              <a:defRPr sz="420"/>
            </a:lvl5pPr>
            <a:lvl6pPr marL="600075" indent="0" algn="ctr">
              <a:buNone/>
              <a:defRPr sz="420"/>
            </a:lvl6pPr>
            <a:lvl7pPr marL="720090" indent="0" algn="ctr">
              <a:buNone/>
              <a:defRPr sz="420"/>
            </a:lvl7pPr>
            <a:lvl8pPr marL="840105" indent="0" algn="ctr">
              <a:buNone/>
              <a:defRPr sz="420"/>
            </a:lvl8pPr>
            <a:lvl9pPr marL="960120" indent="0" algn="ctr">
              <a:buNone/>
              <a:defRPr sz="4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155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8550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14627" y="95846"/>
            <a:ext cx="1420564" cy="152560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2933" y="95846"/>
            <a:ext cx="4179342" cy="152560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0014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2962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9502" y="448807"/>
            <a:ext cx="5682258" cy="748843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9502" y="1204734"/>
            <a:ext cx="5682258" cy="393799"/>
          </a:xfrm>
        </p:spPr>
        <p:txBody>
          <a:bodyPr/>
          <a:lstStyle>
            <a:lvl1pPr marL="0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1pPr>
            <a:lvl2pPr marL="120015" indent="0">
              <a:buNone/>
              <a:defRPr sz="525">
                <a:solidFill>
                  <a:schemeClr val="tx1">
                    <a:tint val="75000"/>
                  </a:schemeClr>
                </a:solidFill>
              </a:defRPr>
            </a:lvl2pPr>
            <a:lvl3pPr marL="240030" indent="0">
              <a:buNone/>
              <a:defRPr sz="472">
                <a:solidFill>
                  <a:schemeClr val="tx1">
                    <a:tint val="75000"/>
                  </a:schemeClr>
                </a:solidFill>
              </a:defRPr>
            </a:lvl3pPr>
            <a:lvl4pPr marL="36004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4pPr>
            <a:lvl5pPr marL="48006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5pPr>
            <a:lvl6pPr marL="60007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6pPr>
            <a:lvl7pPr marL="72009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7pPr>
            <a:lvl8pPr marL="84010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8pPr>
            <a:lvl9pPr marL="96012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14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2934" y="479227"/>
            <a:ext cx="2799953" cy="11422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35238" y="479227"/>
            <a:ext cx="2799953" cy="11422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3347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95846"/>
            <a:ext cx="5682258" cy="34796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3792" y="441305"/>
            <a:ext cx="2787085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3792" y="657582"/>
            <a:ext cx="2787085" cy="9672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35238" y="441305"/>
            <a:ext cx="2800811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35238" y="657582"/>
            <a:ext cx="2800811" cy="9672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4162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7126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367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120015"/>
            <a:ext cx="2124842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0811" y="259199"/>
            <a:ext cx="3335238" cy="1279327"/>
          </a:xfrm>
        </p:spPr>
        <p:txBody>
          <a:bodyPr/>
          <a:lstStyle>
            <a:lvl1pPr>
              <a:defRPr sz="840"/>
            </a:lvl1pPr>
            <a:lvl2pPr>
              <a:defRPr sz="735"/>
            </a:lvl2pPr>
            <a:lvl3pPr>
              <a:defRPr sz="630"/>
            </a:lvl3pPr>
            <a:lvl4pPr>
              <a:defRPr sz="525"/>
            </a:lvl4pPr>
            <a:lvl5pPr>
              <a:defRPr sz="525"/>
            </a:lvl5pPr>
            <a:lvl6pPr>
              <a:defRPr sz="525"/>
            </a:lvl6pPr>
            <a:lvl7pPr>
              <a:defRPr sz="525"/>
            </a:lvl7pPr>
            <a:lvl8pPr>
              <a:defRPr sz="525"/>
            </a:lvl8pPr>
            <a:lvl9pPr>
              <a:defRPr sz="5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540067"/>
            <a:ext cx="2124842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8061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120015"/>
            <a:ext cx="2124842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00811" y="259199"/>
            <a:ext cx="3335238" cy="1279327"/>
          </a:xfrm>
        </p:spPr>
        <p:txBody>
          <a:bodyPr anchor="t"/>
          <a:lstStyle>
            <a:lvl1pPr marL="0" indent="0">
              <a:buNone/>
              <a:defRPr sz="840"/>
            </a:lvl1pPr>
            <a:lvl2pPr marL="120015" indent="0">
              <a:buNone/>
              <a:defRPr sz="735"/>
            </a:lvl2pPr>
            <a:lvl3pPr marL="240030" indent="0">
              <a:buNone/>
              <a:defRPr sz="630"/>
            </a:lvl3pPr>
            <a:lvl4pPr marL="360045" indent="0">
              <a:buNone/>
              <a:defRPr sz="525"/>
            </a:lvl4pPr>
            <a:lvl5pPr marL="480060" indent="0">
              <a:buNone/>
              <a:defRPr sz="525"/>
            </a:lvl5pPr>
            <a:lvl6pPr marL="600075" indent="0">
              <a:buNone/>
              <a:defRPr sz="525"/>
            </a:lvl6pPr>
            <a:lvl7pPr marL="720090" indent="0">
              <a:buNone/>
              <a:defRPr sz="525"/>
            </a:lvl7pPr>
            <a:lvl8pPr marL="840105" indent="0">
              <a:buNone/>
              <a:defRPr sz="525"/>
            </a:lvl8pPr>
            <a:lvl9pPr marL="960120" indent="0">
              <a:buNone/>
              <a:defRPr sz="5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540067"/>
            <a:ext cx="2124842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9828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2934" y="95846"/>
            <a:ext cx="5682258" cy="3479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934" y="479227"/>
            <a:ext cx="5682258" cy="11422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2934" y="1668542"/>
            <a:ext cx="1482328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E4437-8C2C-4450-8620-108744FDA0DE}" type="datetimeFigureOut">
              <a:rPr lang="en-AU" smtClean="0"/>
              <a:t>16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2317" y="1668542"/>
            <a:ext cx="2223492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2863" y="1668542"/>
            <a:ext cx="1482328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AFACF-9233-4688-82A0-5C0BC4A2352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3170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40030" rtl="0" eaLnBrk="1" latinLnBrk="0" hangingPunct="1">
        <a:lnSpc>
          <a:spcPct val="90000"/>
        </a:lnSpc>
        <a:spcBef>
          <a:spcPct val="0"/>
        </a:spcBef>
        <a:buNone/>
        <a:defRPr sz="11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08" indent="-60008" algn="l" defTabSz="24003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735" kern="1200">
          <a:solidFill>
            <a:schemeClr val="tx1"/>
          </a:solidFill>
          <a:latin typeface="+mn-lt"/>
          <a:ea typeface="+mn-ea"/>
          <a:cs typeface="+mn-cs"/>
        </a:defRPr>
      </a:lvl1pPr>
      <a:lvl2pPr marL="18002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2pPr>
      <a:lvl3pPr marL="30003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525" kern="1200">
          <a:solidFill>
            <a:schemeClr val="tx1"/>
          </a:solidFill>
          <a:latin typeface="+mn-lt"/>
          <a:ea typeface="+mn-ea"/>
          <a:cs typeface="+mn-cs"/>
        </a:defRPr>
      </a:lvl3pPr>
      <a:lvl4pPr marL="42005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54006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6008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8009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90011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102012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1pPr>
      <a:lvl2pPr marL="12001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2pPr>
      <a:lvl3pPr marL="24003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48006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0007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2009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84010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96012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6E21C7A-9A4C-40EF-9DA1-818A2E2149F2}"/>
              </a:ext>
            </a:extLst>
          </p:cNvPr>
          <p:cNvGrpSpPr/>
          <p:nvPr/>
        </p:nvGrpSpPr>
        <p:grpSpPr>
          <a:xfrm>
            <a:off x="125" y="4230"/>
            <a:ext cx="6588000" cy="1801504"/>
            <a:chOff x="42360" y="0"/>
            <a:chExt cx="6592614" cy="1801504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4942E90-4E16-4B4A-8CBD-7E4B9E3C0415}"/>
                </a:ext>
              </a:extLst>
            </p:cNvPr>
            <p:cNvSpPr/>
            <p:nvPr/>
          </p:nvSpPr>
          <p:spPr>
            <a:xfrm>
              <a:off x="48702" y="0"/>
              <a:ext cx="6586272" cy="18015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01A2B77-54CC-492C-8CF9-4B86B24AD0AA}"/>
                </a:ext>
              </a:extLst>
            </p:cNvPr>
            <p:cNvSpPr txBox="1"/>
            <p:nvPr/>
          </p:nvSpPr>
          <p:spPr>
            <a:xfrm>
              <a:off x="42360" y="6822"/>
              <a:ext cx="24237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8101E68-D0E2-45F9-A0E6-3A35D8FC0677}"/>
                </a:ext>
              </a:extLst>
            </p:cNvPr>
            <p:cNvSpPr txBox="1"/>
            <p:nvPr/>
          </p:nvSpPr>
          <p:spPr>
            <a:xfrm>
              <a:off x="2167588" y="6822"/>
              <a:ext cx="24718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E01AE7-B870-4104-A7DA-88EC66A1C500}"/>
                </a:ext>
              </a:extLst>
            </p:cNvPr>
            <p:cNvSpPr txBox="1"/>
            <p:nvPr/>
          </p:nvSpPr>
          <p:spPr>
            <a:xfrm>
              <a:off x="4297627" y="6822"/>
              <a:ext cx="24237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68FFD64-8DF0-4853-A576-13E7ED1FDD92}"/>
                </a:ext>
              </a:extLst>
            </p:cNvPr>
            <p:cNvGrpSpPr/>
            <p:nvPr/>
          </p:nvGrpSpPr>
          <p:grpSpPr>
            <a:xfrm>
              <a:off x="4862725" y="815255"/>
              <a:ext cx="1411096" cy="832453"/>
              <a:chOff x="8645125" y="2980935"/>
              <a:chExt cx="2457674" cy="1581405"/>
            </a:xfrm>
            <a:noFill/>
          </p:grpSpPr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F0B646FE-2A40-4EF8-A7DA-28CB752670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985951" y="3363110"/>
                <a:ext cx="0" cy="705804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9D04B7D0-D8B2-4B91-8428-773FE4C7DD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525355" y="2980935"/>
                <a:ext cx="5295" cy="1093164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9379D1DB-A983-4345-8820-3E9BD5B7241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070054" y="3441623"/>
                <a:ext cx="9289" cy="638267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DDCE599C-B38F-4FF2-894C-1A50CF3F1C1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618746" y="3709632"/>
                <a:ext cx="0" cy="351181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3D6E98E-F2A2-4C96-BEC6-4D73F48CE6BD}"/>
                  </a:ext>
                </a:extLst>
              </p:cNvPr>
              <p:cNvSpPr txBox="1"/>
              <p:nvPr/>
            </p:nvSpPr>
            <p:spPr>
              <a:xfrm>
                <a:off x="8696050" y="4182297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F410671E-B305-40D1-88BE-D87368756C8C}"/>
                  </a:ext>
                </a:extLst>
              </p:cNvPr>
              <p:cNvSpPr txBox="1"/>
              <p:nvPr/>
            </p:nvSpPr>
            <p:spPr>
              <a:xfrm>
                <a:off x="9264345" y="4182297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1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E95E9B2-D980-4961-BFD5-B22788DCF9D5}"/>
                  </a:ext>
                </a:extLst>
              </p:cNvPr>
              <p:cNvSpPr txBox="1"/>
              <p:nvPr/>
            </p:nvSpPr>
            <p:spPr>
              <a:xfrm>
                <a:off x="9832640" y="4182297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2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3B4D2455-97B5-4225-8624-D01EDDF5EEC3}"/>
                  </a:ext>
                </a:extLst>
              </p:cNvPr>
              <p:cNvSpPr txBox="1"/>
              <p:nvPr/>
            </p:nvSpPr>
            <p:spPr>
              <a:xfrm>
                <a:off x="10400934" y="4182297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3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32F3E04E-EEF4-4FD2-9A8B-91AFD735B8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645125" y="4086308"/>
                <a:ext cx="2457674" cy="0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767C032-BCAA-484A-B1E6-D3160C882E58}"/>
                </a:ext>
              </a:extLst>
            </p:cNvPr>
            <p:cNvSpPr txBox="1"/>
            <p:nvPr/>
          </p:nvSpPr>
          <p:spPr>
            <a:xfrm>
              <a:off x="556877" y="150041"/>
              <a:ext cx="1288312" cy="20005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Un-labelled </a:t>
              </a:r>
              <a:r>
                <a:rPr lang="en-US" sz="700" b="1" err="1">
                  <a:latin typeface="Arial" panose="020B0604020202020204" pitchFamily="34" charset="0"/>
                  <a:cs typeface="Arial" panose="020B0604020202020204" pitchFamily="34" charset="0"/>
                </a:rPr>
                <a:t>isotopologue</a:t>
              </a:r>
              <a:endParaRPr lang="en-AU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3D0FB2EF-2EF9-484A-AEF9-7C93B3B12F42}"/>
                </a:ext>
              </a:extLst>
            </p:cNvPr>
            <p:cNvGrpSpPr/>
            <p:nvPr/>
          </p:nvGrpSpPr>
          <p:grpSpPr>
            <a:xfrm>
              <a:off x="484960" y="647567"/>
              <a:ext cx="1411096" cy="1071157"/>
              <a:chOff x="469166" y="2575135"/>
              <a:chExt cx="2457674" cy="2034869"/>
            </a:xfrm>
            <a:noFill/>
          </p:grpSpPr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A3862BE0-8890-44C8-B865-DE105C7F62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9166" y="4127214"/>
                <a:ext cx="2457674" cy="0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7B58B1E4-B861-4E5A-94FD-DA4A6C3EBB0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0985" y="2575135"/>
                <a:ext cx="9152" cy="1527398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564B5249-220E-4A9F-A20D-2A1D928AFD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76802" y="3770988"/>
                <a:ext cx="0" cy="356226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280DD84B-99C5-44B6-9BA2-641D9A5DF66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898721" y="3875803"/>
                <a:ext cx="1" cy="251294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929A3B16-F3F1-4DC3-B692-CFC9E24ECE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20639" y="4021721"/>
                <a:ext cx="0" cy="85419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685D38F-262B-4529-A2F6-31E2310E3672}"/>
                  </a:ext>
                </a:extLst>
              </p:cNvPr>
              <p:cNvSpPr txBox="1"/>
              <p:nvPr/>
            </p:nvSpPr>
            <p:spPr>
              <a:xfrm>
                <a:off x="570960" y="4205579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79AA499-735B-4888-939A-7C8E0134DD45}"/>
                  </a:ext>
                </a:extLst>
              </p:cNvPr>
              <p:cNvSpPr txBox="1"/>
              <p:nvPr/>
            </p:nvSpPr>
            <p:spPr>
              <a:xfrm>
                <a:off x="1130399" y="421321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1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8196E88-A17F-435D-B842-DB20BD73F4FB}"/>
                  </a:ext>
                </a:extLst>
              </p:cNvPr>
              <p:cNvSpPr txBox="1"/>
              <p:nvPr/>
            </p:nvSpPr>
            <p:spPr>
              <a:xfrm>
                <a:off x="1669960" y="421321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2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C80B460-872C-437F-9CD1-88F67419E652}"/>
                  </a:ext>
                </a:extLst>
              </p:cNvPr>
              <p:cNvSpPr txBox="1"/>
              <p:nvPr/>
            </p:nvSpPr>
            <p:spPr>
              <a:xfrm>
                <a:off x="2229397" y="421321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3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4A9635A3-3347-4FD6-A219-D7FE8EBC9AB8}"/>
                  </a:ext>
                </a:extLst>
              </p:cNvPr>
              <p:cNvSpPr/>
              <p:nvPr/>
            </p:nvSpPr>
            <p:spPr>
              <a:xfrm>
                <a:off x="1131180" y="3347712"/>
                <a:ext cx="1695721" cy="1262292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4DE1E265-76AE-4DB3-92FC-71EF6ED8F8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46103" y="918070"/>
              <a:ext cx="107067" cy="13969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CD77F44-58CB-420F-904C-753BED7B9B6E}"/>
                </a:ext>
              </a:extLst>
            </p:cNvPr>
            <p:cNvSpPr txBox="1"/>
            <p:nvPr/>
          </p:nvSpPr>
          <p:spPr>
            <a:xfrm>
              <a:off x="1257763" y="579436"/>
              <a:ext cx="8274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atural isotopic 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  <a:endParaRPr lang="en-AU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BC073CA-F36A-4B0C-A2BA-3B2265B64411}"/>
                </a:ext>
              </a:extLst>
            </p:cNvPr>
            <p:cNvSpPr txBox="1"/>
            <p:nvPr/>
          </p:nvSpPr>
          <p:spPr>
            <a:xfrm rot="16200000">
              <a:off x="-256619" y="887889"/>
              <a:ext cx="1176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Relative Abundance</a:t>
              </a:r>
              <a:endParaRPr lang="en-A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7BD9BA7-E57C-4F6C-A1F2-4A7BE495B7A8}"/>
                </a:ext>
              </a:extLst>
            </p:cNvPr>
            <p:cNvSpPr txBox="1"/>
            <p:nvPr/>
          </p:nvSpPr>
          <p:spPr>
            <a:xfrm>
              <a:off x="2654653" y="145859"/>
              <a:ext cx="1348029" cy="20005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ully-labelled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sotopologue</a:t>
              </a:r>
              <a:endParaRPr lang="en-A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8447A2B-81DD-43E6-B311-D6883F8887CE}"/>
                </a:ext>
              </a:extLst>
            </p:cNvPr>
            <p:cNvSpPr txBox="1"/>
            <p:nvPr/>
          </p:nvSpPr>
          <p:spPr>
            <a:xfrm>
              <a:off x="4781419" y="145859"/>
              <a:ext cx="1502480" cy="20005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Partially-labelled </a:t>
              </a:r>
              <a:r>
                <a:rPr lang="en-US" sz="700" b="1" err="1">
                  <a:latin typeface="Arial" panose="020B0604020202020204" pitchFamily="34" charset="0"/>
                  <a:cs typeface="Arial" panose="020B0604020202020204" pitchFamily="34" charset="0"/>
                </a:rPr>
                <a:t>isotopologue</a:t>
              </a:r>
              <a:endParaRPr lang="en-AU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D56E217-6712-4C4F-A112-EA781D4E0399}"/>
                </a:ext>
              </a:extLst>
            </p:cNvPr>
            <p:cNvGrpSpPr/>
            <p:nvPr/>
          </p:nvGrpSpPr>
          <p:grpSpPr>
            <a:xfrm>
              <a:off x="2673843" y="761569"/>
              <a:ext cx="1411096" cy="939824"/>
              <a:chOff x="5134385" y="2771590"/>
              <a:chExt cx="2457674" cy="1785377"/>
            </a:xfrm>
            <a:noFill/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B394C306-1CFD-4638-904F-D36DEE13CB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34385" y="4094741"/>
                <a:ext cx="2457674" cy="0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8B09FEEA-12CA-415F-9D8B-B72726861D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050878" y="2771590"/>
                <a:ext cx="0" cy="1298470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3BD4BD47-CB3B-4628-8511-D80196C298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74517" y="3738515"/>
                <a:ext cx="0" cy="356226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62026CD1-EAF1-4930-B3D3-D5223FA87A61}"/>
                  </a:ext>
                </a:extLst>
              </p:cNvPr>
              <p:cNvSpPr txBox="1"/>
              <p:nvPr/>
            </p:nvSpPr>
            <p:spPr>
              <a:xfrm>
                <a:off x="5216301" y="417692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A07D0B9-56BE-4713-99FB-518821F87DE7}"/>
                  </a:ext>
                </a:extLst>
              </p:cNvPr>
              <p:cNvSpPr txBox="1"/>
              <p:nvPr/>
            </p:nvSpPr>
            <p:spPr>
              <a:xfrm>
                <a:off x="5784597" y="417692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1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08806EE-EBF3-4C96-9E34-A36300BAA23C}"/>
                  </a:ext>
                </a:extLst>
              </p:cNvPr>
              <p:cNvSpPr txBox="1"/>
              <p:nvPr/>
            </p:nvSpPr>
            <p:spPr>
              <a:xfrm>
                <a:off x="6352892" y="417692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2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D41EB0F-2C9F-44C5-85BC-0DF60397C340}"/>
                  </a:ext>
                </a:extLst>
              </p:cNvPr>
              <p:cNvSpPr txBox="1"/>
              <p:nvPr/>
            </p:nvSpPr>
            <p:spPr>
              <a:xfrm>
                <a:off x="6921186" y="4176924"/>
                <a:ext cx="539397" cy="380043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M3</a:t>
                </a:r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9F7777F0-78CF-4E72-8752-C4F94F93C7B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098155" y="3981687"/>
                <a:ext cx="0" cy="85419"/>
              </a:xfrm>
              <a:prstGeom prst="line">
                <a:avLst/>
              </a:prstGeom>
              <a:grpFill/>
              <a:ln w="38100" cap="rnd">
                <a:round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270441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7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heen Farzana</dc:creator>
  <cp:lastModifiedBy>Farheen Farzana</cp:lastModifiedBy>
  <cp:revision>1</cp:revision>
  <dcterms:created xsi:type="dcterms:W3CDTF">2022-04-16T06:17:17Z</dcterms:created>
  <dcterms:modified xsi:type="dcterms:W3CDTF">2022-04-16T06:18:38Z</dcterms:modified>
</cp:coreProperties>
</file>